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97FD9-4C78-4DE8-A4AC-B0E2BCD6F2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0D32B-FFCC-447A-B81C-92494A3B7F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1F62E0-A6E4-4CC6-BB44-BD90420ACE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0BB37-F618-477F-985C-8E018B64BA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9A2BD-8664-48F8-B88C-E3F87153C6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8FFC3A-C8F2-4C93-8D8D-3C309154FB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E7AB5-87AF-4FC2-ADC2-54C213A0EF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E604B-AF19-4FF2-ACC5-D7F0287B24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62CD2E-6AF6-4C29-BBF8-BF8FA6CCC4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1C43E-B6FF-4A16-BA7A-A994D59EBF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9BE82-4A04-4BD9-91C9-EA3EDC2AC3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186C2-6C6D-4682-98DA-EDA3A5CB20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061BCE-28BA-41A0-BC2D-FD820E5FEDED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136800" y="6453360"/>
            <a:ext cx="273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1: 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rcRect l="0" t="0" r="9605" b="0"/>
          <a:stretch/>
        </p:blipFill>
        <p:spPr>
          <a:xfrm>
            <a:off x="611280" y="139680"/>
            <a:ext cx="3384360" cy="2808360"/>
          </a:xfrm>
          <a:prstGeom prst="rect">
            <a:avLst/>
          </a:prstGeom>
          <a:ln w="0">
            <a:noFill/>
          </a:ln>
        </p:spPr>
      </p:pic>
      <p:sp>
        <p:nvSpPr>
          <p:cNvPr id="43" name="TextBox 5"/>
          <p:cNvSpPr/>
          <p:nvPr/>
        </p:nvSpPr>
        <p:spPr>
          <a:xfrm>
            <a:off x="862560" y="2916360"/>
            <a:ext cx="249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atient 1#: female, 3.5 years ol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3" descr=""/>
          <p:cNvPicPr/>
          <p:nvPr/>
        </p:nvPicPr>
        <p:blipFill>
          <a:blip r:embed="rId2"/>
          <a:stretch/>
        </p:blipFill>
        <p:spPr>
          <a:xfrm>
            <a:off x="4865760" y="142920"/>
            <a:ext cx="3744720" cy="2808360"/>
          </a:xfrm>
          <a:prstGeom prst="rect">
            <a:avLst/>
          </a:prstGeom>
          <a:ln w="0">
            <a:noFill/>
          </a:ln>
        </p:spPr>
      </p:pic>
      <p:sp>
        <p:nvSpPr>
          <p:cNvPr id="45" name="TextBox 7"/>
          <p:cNvSpPr/>
          <p:nvPr/>
        </p:nvSpPr>
        <p:spPr>
          <a:xfrm>
            <a:off x="5686200" y="2924280"/>
            <a:ext cx="240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atient 2#: male, five years ol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4" descr=""/>
          <p:cNvPicPr/>
          <p:nvPr/>
        </p:nvPicPr>
        <p:blipFill>
          <a:blip r:embed="rId3"/>
          <a:srcRect l="2887" t="0" r="0" b="0"/>
          <a:stretch/>
        </p:blipFill>
        <p:spPr>
          <a:xfrm>
            <a:off x="2017800" y="3284640"/>
            <a:ext cx="4848120" cy="2808360"/>
          </a:xfrm>
          <a:prstGeom prst="rect">
            <a:avLst/>
          </a:prstGeom>
          <a:ln w="0">
            <a:noFill/>
          </a:ln>
        </p:spPr>
      </p:pic>
      <p:sp>
        <p:nvSpPr>
          <p:cNvPr id="47" name="TextBox 9"/>
          <p:cNvSpPr/>
          <p:nvPr/>
        </p:nvSpPr>
        <p:spPr>
          <a:xfrm>
            <a:off x="3384000" y="6083280"/>
            <a:ext cx="235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atient 3#: male, 5.5 years ol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3-18T07:39:14Z</dcterms:created>
  <dc:creator>ZZG</dc:creator>
  <dc:description/>
  <dc:language>en-US</dc:language>
  <cp:lastModifiedBy>ZZG</cp:lastModifiedBy>
  <dcterms:modified xsi:type="dcterms:W3CDTF">2016-04-11T02:13:16Z</dcterms:modified>
  <cp:revision>17</cp:revision>
  <dc:subject/>
  <dc:title>幻灯片 1</dc:title>
</cp:coreProperties>
</file>